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2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4B47-6386-4A76-B167-F0D4365222E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AB7D1-A79E-47F5-9F89-7C69250E7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35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8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649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6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61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94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622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62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73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3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5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696524C0-5BFD-0FCB-1F2E-8ACDBC1BE5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3442927"/>
              </p:ext>
            </p:extLst>
          </p:nvPr>
        </p:nvGraphicFramePr>
        <p:xfrm>
          <a:off x="207818" y="521732"/>
          <a:ext cx="2084388" cy="2917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9" r:id="rId3" imgW="2084495" imgH="2918209" progId="Prism9.Document">
                  <p:embed/>
                </p:oleObj>
              </mc:Choice>
              <mc:Fallback>
                <p:oleObj name="Prism 9" r:id="rId3" imgW="2084495" imgH="2918209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696524C0-5BFD-0FCB-1F2E-8ACDBC1BE5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7818" y="521732"/>
                        <a:ext cx="2084388" cy="2917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1296F96-BD69-0B5C-1293-B062C3E0482A}"/>
              </a:ext>
            </a:extLst>
          </p:cNvPr>
          <p:cNvSpPr txBox="1"/>
          <p:nvPr/>
        </p:nvSpPr>
        <p:spPr>
          <a:xfrm>
            <a:off x="207818" y="152400"/>
            <a:ext cx="29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5C7A5F8-6C39-6304-480A-08AAAE959A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9712760"/>
              </p:ext>
            </p:extLst>
          </p:nvPr>
        </p:nvGraphicFramePr>
        <p:xfrm>
          <a:off x="400583" y="3665395"/>
          <a:ext cx="5562876" cy="2890316"/>
        </p:xfrm>
        <a:graphic>
          <a:graphicData uri="http://schemas.openxmlformats.org/drawingml/2006/table">
            <a:tbl>
              <a:tblPr/>
              <a:tblGrid>
                <a:gridCol w="480377">
                  <a:extLst>
                    <a:ext uri="{9D8B030D-6E8A-4147-A177-3AD203B41FA5}">
                      <a16:colId xmlns:a16="http://schemas.microsoft.com/office/drawing/2014/main" val="778697264"/>
                    </a:ext>
                  </a:extLst>
                </a:gridCol>
                <a:gridCol w="480377">
                  <a:extLst>
                    <a:ext uri="{9D8B030D-6E8A-4147-A177-3AD203B41FA5}">
                      <a16:colId xmlns:a16="http://schemas.microsoft.com/office/drawing/2014/main" val="2121485505"/>
                    </a:ext>
                  </a:extLst>
                </a:gridCol>
                <a:gridCol w="757244">
                  <a:extLst>
                    <a:ext uri="{9D8B030D-6E8A-4147-A177-3AD203B41FA5}">
                      <a16:colId xmlns:a16="http://schemas.microsoft.com/office/drawing/2014/main" val="1537589579"/>
                    </a:ext>
                  </a:extLst>
                </a:gridCol>
                <a:gridCol w="959788">
                  <a:extLst>
                    <a:ext uri="{9D8B030D-6E8A-4147-A177-3AD203B41FA5}">
                      <a16:colId xmlns:a16="http://schemas.microsoft.com/office/drawing/2014/main" val="1494369530"/>
                    </a:ext>
                  </a:extLst>
                </a:gridCol>
                <a:gridCol w="614482">
                  <a:extLst>
                    <a:ext uri="{9D8B030D-6E8A-4147-A177-3AD203B41FA5}">
                      <a16:colId xmlns:a16="http://schemas.microsoft.com/office/drawing/2014/main" val="2855398088"/>
                    </a:ext>
                  </a:extLst>
                </a:gridCol>
                <a:gridCol w="886772">
                  <a:extLst>
                    <a:ext uri="{9D8B030D-6E8A-4147-A177-3AD203B41FA5}">
                      <a16:colId xmlns:a16="http://schemas.microsoft.com/office/drawing/2014/main" val="873454938"/>
                    </a:ext>
                  </a:extLst>
                </a:gridCol>
                <a:gridCol w="757244">
                  <a:extLst>
                    <a:ext uri="{9D8B030D-6E8A-4147-A177-3AD203B41FA5}">
                      <a16:colId xmlns:a16="http://schemas.microsoft.com/office/drawing/2014/main" val="1015977686"/>
                    </a:ext>
                  </a:extLst>
                </a:gridCol>
                <a:gridCol w="626592">
                  <a:extLst>
                    <a:ext uri="{9D8B030D-6E8A-4147-A177-3AD203B41FA5}">
                      <a16:colId xmlns:a16="http://schemas.microsoft.com/office/drawing/2014/main" val="2497567215"/>
                    </a:ext>
                  </a:extLst>
                </a:gridCol>
              </a:tblGrid>
              <a:tr h="318427">
                <a:tc>
                  <a:txBody>
                    <a:bodyPr/>
                    <a:lstStyle/>
                    <a:p>
                      <a:pPr algn="ctr" fontAlgn="ctr"/>
                      <a:endParaRPr lang="ja-JP" alt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sex</a:t>
                      </a:r>
                      <a:endParaRPr lang="ja-JP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ge</a:t>
                      </a:r>
                      <a:endParaRPr lang="ja-JP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OS</a:t>
                      </a:r>
                    </a:p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(month)</a:t>
                      </a:r>
                      <a:endParaRPr lang="ja-JP" alt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CA19-9</a:t>
                      </a:r>
                    </a:p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(U/ml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DUPAN2</a:t>
                      </a:r>
                    </a:p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(U/ml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Diameter</a:t>
                      </a:r>
                    </a:p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mm)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Stage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7318186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endParaRPr lang="ja-JP" altLang="en-US" sz="1600" b="1" i="0" u="none" strike="noStrike" dirty="0">
                        <a:solidFill>
                          <a:schemeClr val="bg1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F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9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8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ⅡB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4631151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401.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9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Ⅱ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8242139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04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err="1">
                          <a:solidFill>
                            <a:schemeClr val="bg1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ⅡA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4200754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vg.</a:t>
                      </a:r>
                      <a:endParaRPr lang="ja-JP" alt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7.33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5.666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48.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6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4.66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2808352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3.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1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Ⅱ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3933705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9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3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Ⅱ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1682659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62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Ⅱ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7640759"/>
                  </a:ext>
                </a:extLst>
              </a:tr>
              <a:tr h="31842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Avg.</a:t>
                      </a:r>
                      <a:endParaRPr lang="ja-JP" alt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71.66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81.33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6.533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5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25.66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9647912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284DDD5-AA79-BA05-E52F-607F2858E8FA}"/>
              </a:ext>
            </a:extLst>
          </p:cNvPr>
          <p:cNvSpPr txBox="1"/>
          <p:nvPr/>
        </p:nvSpPr>
        <p:spPr>
          <a:xfrm>
            <a:off x="409817" y="532085"/>
            <a:ext cx="4722622" cy="6463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824439B-43BA-4BF5-A958-91FE6D4BE29F}"/>
              </a:ext>
            </a:extLst>
          </p:cNvPr>
          <p:cNvSpPr txBox="1"/>
          <p:nvPr/>
        </p:nvSpPr>
        <p:spPr>
          <a:xfrm>
            <a:off x="197069" y="8024719"/>
            <a:ext cx="646386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Clinical status of pancreatic cancer patients analyzed by RNA sequencing. 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 Comparison of serum CA19-9 levels between CA19-9–high poor prognosis and CA19-9–low favorable prognosis groups (t-test, p = 0.0186). 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 Patient demographics and clinical parameters (mean, minimum, and maximum values shown).</a:t>
            </a:r>
          </a:p>
        </p:txBody>
      </p:sp>
    </p:spTree>
    <p:extLst>
      <p:ext uri="{BB962C8B-B14F-4D97-AF65-F5344CB8AC3E}">
        <p14:creationId xmlns:p14="http://schemas.microsoft.com/office/powerpoint/2010/main" val="1838108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29</TotalTime>
  <Words>158</Words>
  <Application>Microsoft Office PowerPoint</Application>
  <PresentationFormat>A4 210 x 297 mm</PresentationFormat>
  <Paragraphs>99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平 典之</dc:creator>
  <cp:lastModifiedBy>道上 宏之</cp:lastModifiedBy>
  <cp:revision>192</cp:revision>
  <dcterms:created xsi:type="dcterms:W3CDTF">2022-06-29T03:55:00Z</dcterms:created>
  <dcterms:modified xsi:type="dcterms:W3CDTF">2025-08-06T07:07:18Z</dcterms:modified>
</cp:coreProperties>
</file>